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6859588" cy="901541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422" y="-72"/>
      </p:cViewPr>
      <p:guideLst>
        <p:guide orient="horz" pos="2840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0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.bin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4.bin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5.bin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6.bin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7.bin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8.bin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9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s-ES" dirty="0" smtClean="0"/>
              <a:t>III-3</a:t>
            </a:r>
            <a:endParaRPr lang="es-ES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9.9206541431325623E-2"/>
          <c:y val="7.3825624321033984E-2"/>
          <c:w val="0.87301756459566549"/>
          <c:h val="0.674497749478537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2</c:f>
              <c:strCache>
                <c:ptCount val="1"/>
                <c:pt idx="0">
                  <c:v>1158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B$6:$B$54</c:f>
              <c:strCache>
                <c:ptCount val="49"/>
                <c:pt idx="0">
                  <c:v>NIPA1 (BP1-BP2)</c:v>
                </c:pt>
                <c:pt idx="1">
                  <c:v>TUBGCP5 (BP1-BP2)</c:v>
                </c:pt>
                <c:pt idx="2">
                  <c:v>MKRN3 (exon1)</c:v>
                </c:pt>
                <c:pt idx="3">
                  <c:v>MAGEL2 (EXON1)</c:v>
                </c:pt>
                <c:pt idx="4">
                  <c:v>MAGEL2 (EXON 1)</c:v>
                </c:pt>
                <c:pt idx="5">
                  <c:v>NDN (exon1)</c:v>
                </c:pt>
                <c:pt idx="6">
                  <c:v>SNRPN (exon U1B)</c:v>
                </c:pt>
                <c:pt idx="7">
                  <c:v>SNRPN (exon U1B)</c:v>
                </c:pt>
                <c:pt idx="8">
                  <c:v>SNRPN (intron U2)</c:v>
                </c:pt>
                <c:pt idx="9">
                  <c:v>SNRPN (intron U2)</c:v>
                </c:pt>
                <c:pt idx="10">
                  <c:v>SNRPN (exonU5)</c:v>
                </c:pt>
                <c:pt idx="11">
                  <c:v>SNRPN (exonU5-AS-SRO)</c:v>
                </c:pt>
                <c:pt idx="12">
                  <c:v>SNRPN (exon3)</c:v>
                </c:pt>
                <c:pt idx="13">
                  <c:v>SNRPN (exon3)</c:v>
                </c:pt>
                <c:pt idx="14">
                  <c:v>SNRPN (intron3)</c:v>
                </c:pt>
                <c:pt idx="15">
                  <c:v>SNRPN (exon3)</c:v>
                </c:pt>
                <c:pt idx="16">
                  <c:v>SNURF-SNRPN (exon3)</c:v>
                </c:pt>
                <c:pt idx="17">
                  <c:v>SNRPN (Exon7)</c:v>
                </c:pt>
                <c:pt idx="18">
                  <c:v>SNRPN (SNORD116-1)</c:v>
                </c:pt>
                <c:pt idx="19">
                  <c:v>SNRPN  (SNORD116-11)</c:v>
                </c:pt>
                <c:pt idx="20">
                  <c:v>SNRPN  (SNORD116-23)</c:v>
                </c:pt>
                <c:pt idx="21">
                  <c:v>UBE3A (exon9)</c:v>
                </c:pt>
                <c:pt idx="22">
                  <c:v>UBE3A (exon4)</c:v>
                </c:pt>
                <c:pt idx="23">
                  <c:v>UBE3A (exon7)</c:v>
                </c:pt>
                <c:pt idx="24">
                  <c:v>UBE3A (exon2)</c:v>
                </c:pt>
                <c:pt idx="25">
                  <c:v>UBE3A (exon1)</c:v>
                </c:pt>
                <c:pt idx="26">
                  <c:v>UBE3A (exon1)</c:v>
                </c:pt>
                <c:pt idx="27">
                  <c:v>ATP10A (exon15)</c:v>
                </c:pt>
                <c:pt idx="28">
                  <c:v>ATP10A (exon1)</c:v>
                </c:pt>
                <c:pt idx="29">
                  <c:v>GABRB3</c:v>
                </c:pt>
                <c:pt idx="30">
                  <c:v>GABRB3</c:v>
                </c:pt>
                <c:pt idx="31">
                  <c:v>OCA2 (exon23)</c:v>
                </c:pt>
                <c:pt idx="32">
                  <c:v>OCA2 (exon3)</c:v>
                </c:pt>
                <c:pt idx="33">
                  <c:v>APBA2 (exon14)</c:v>
                </c:pt>
                <c:pt idx="34">
                  <c:v>1q23</c:v>
                </c:pt>
                <c:pt idx="35">
                  <c:v>2q12</c:v>
                </c:pt>
                <c:pt idx="36">
                  <c:v>4q12</c:v>
                </c:pt>
                <c:pt idx="37">
                  <c:v>5p15</c:v>
                </c:pt>
                <c:pt idx="38">
                  <c:v>5q31</c:v>
                </c:pt>
                <c:pt idx="39">
                  <c:v>6q24</c:v>
                </c:pt>
                <c:pt idx="40">
                  <c:v>7q21</c:v>
                </c:pt>
                <c:pt idx="41">
                  <c:v>8p21</c:v>
                </c:pt>
                <c:pt idx="42">
                  <c:v>10p11</c:v>
                </c:pt>
                <c:pt idx="43">
                  <c:v>11q24</c:v>
                </c:pt>
                <c:pt idx="44">
                  <c:v>12q13</c:v>
                </c:pt>
                <c:pt idx="45">
                  <c:v>17q12</c:v>
                </c:pt>
                <c:pt idx="46">
                  <c:v>21q22</c:v>
                </c:pt>
                <c:pt idx="47">
                  <c:v>X</c:v>
                </c:pt>
                <c:pt idx="48">
                  <c:v>Y</c:v>
                </c:pt>
              </c:strCache>
            </c:strRef>
          </c:cat>
          <c:val>
            <c:numRef>
              <c:f>Reports!$C$6:$C$54</c:f>
              <c:numCache>
                <c:formatCode>0.00</c:formatCode>
                <c:ptCount val="49"/>
                <c:pt idx="0">
                  <c:v>0.88628165236733325</c:v>
                </c:pt>
                <c:pt idx="1">
                  <c:v>1.1166042045796096</c:v>
                </c:pt>
                <c:pt idx="2">
                  <c:v>1.6776413574409055</c:v>
                </c:pt>
                <c:pt idx="3">
                  <c:v>1.3698771319454541</c:v>
                </c:pt>
                <c:pt idx="4">
                  <c:v>1.5371676660031277</c:v>
                </c:pt>
                <c:pt idx="5">
                  <c:v>1.3664564825282168</c:v>
                </c:pt>
                <c:pt idx="6">
                  <c:v>1.6308326179683885</c:v>
                </c:pt>
                <c:pt idx="7">
                  <c:v>1.4642091444209635</c:v>
                </c:pt>
                <c:pt idx="8">
                  <c:v>1.4681176110380545</c:v>
                </c:pt>
                <c:pt idx="9">
                  <c:v>1.4245346111024608</c:v>
                </c:pt>
                <c:pt idx="10">
                  <c:v>1.5273237526884147</c:v>
                </c:pt>
                <c:pt idx="11">
                  <c:v>1.304714557043682</c:v>
                </c:pt>
                <c:pt idx="12">
                  <c:v>1.4982401527354194</c:v>
                </c:pt>
                <c:pt idx="13">
                  <c:v>1.5965867343087528</c:v>
                </c:pt>
                <c:pt idx="14">
                  <c:v>1.5922112108234585</c:v>
                </c:pt>
                <c:pt idx="15">
                  <c:v>1.7187536653612718</c:v>
                </c:pt>
                <c:pt idx="16">
                  <c:v>1.4650844302882271</c:v>
                </c:pt>
                <c:pt idx="17">
                  <c:v>1.3520846583069703</c:v>
                </c:pt>
                <c:pt idx="18">
                  <c:v>1.532957731486972</c:v>
                </c:pt>
                <c:pt idx="19">
                  <c:v>1.3477590437667015</c:v>
                </c:pt>
                <c:pt idx="20">
                  <c:v>1.4097526419984747</c:v>
                </c:pt>
                <c:pt idx="21">
                  <c:v>1.3331905605574257</c:v>
                </c:pt>
                <c:pt idx="22">
                  <c:v>1.4607323483349648</c:v>
                </c:pt>
                <c:pt idx="23">
                  <c:v>1.5901229633555773</c:v>
                </c:pt>
                <c:pt idx="24">
                  <c:v>1.5749718458095023</c:v>
                </c:pt>
                <c:pt idx="25">
                  <c:v>1.4159379058553185</c:v>
                </c:pt>
                <c:pt idx="26">
                  <c:v>1.464399446554759</c:v>
                </c:pt>
                <c:pt idx="27">
                  <c:v>1.3874500564898589</c:v>
                </c:pt>
                <c:pt idx="28">
                  <c:v>1.4893565843466063</c:v>
                </c:pt>
                <c:pt idx="29">
                  <c:v>1.5604808944313249</c:v>
                </c:pt>
                <c:pt idx="30">
                  <c:v>1.34130741388811</c:v>
                </c:pt>
                <c:pt idx="31">
                  <c:v>1.7194639872275614</c:v>
                </c:pt>
                <c:pt idx="32">
                  <c:v>1.4539513639262625</c:v>
                </c:pt>
                <c:pt idx="33">
                  <c:v>1.015641229950212</c:v>
                </c:pt>
                <c:pt idx="34">
                  <c:v>0.88953431909912239</c:v>
                </c:pt>
                <c:pt idx="35">
                  <c:v>0.93580092482413313</c:v>
                </c:pt>
                <c:pt idx="36">
                  <c:v>1.0271936626709399</c:v>
                </c:pt>
                <c:pt idx="37">
                  <c:v>1.0469154238859899</c:v>
                </c:pt>
                <c:pt idx="38">
                  <c:v>1.2161896747524032</c:v>
                </c:pt>
                <c:pt idx="39">
                  <c:v>0.96346392537576364</c:v>
                </c:pt>
                <c:pt idx="40">
                  <c:v>0.93130185075296845</c:v>
                </c:pt>
                <c:pt idx="41">
                  <c:v>0.87132834600382936</c:v>
                </c:pt>
                <c:pt idx="42">
                  <c:v>0.91996013652354769</c:v>
                </c:pt>
                <c:pt idx="43">
                  <c:v>1.1562301425794697</c:v>
                </c:pt>
                <c:pt idx="44">
                  <c:v>1.0135280694049993</c:v>
                </c:pt>
                <c:pt idx="45">
                  <c:v>1.064158685709979</c:v>
                </c:pt>
                <c:pt idx="46">
                  <c:v>0.86598848434170939</c:v>
                </c:pt>
                <c:pt idx="47">
                  <c:v>1.074095780917399</c:v>
                </c:pt>
                <c:pt idx="48">
                  <c:v>1.20866231294731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3990656"/>
        <c:axId val="154030464"/>
      </c:barChart>
      <c:catAx>
        <c:axId val="153990656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58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54030464"/>
        <c:crosses val="autoZero"/>
        <c:auto val="1"/>
        <c:lblAlgn val="ctr"/>
        <c:lblOffset val="100"/>
        <c:tickMarkSkip val="1"/>
        <c:noMultiLvlLbl val="0"/>
      </c:catAx>
      <c:valAx>
        <c:axId val="154030464"/>
        <c:scaling>
          <c:orientation val="minMax"/>
          <c:max val="2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53990656"/>
        <c:crosses val="autoZero"/>
        <c:crossBetween val="between"/>
      </c:valAx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70852275681993E-2"/>
          <c:y val="5.7356608478802994E-2"/>
          <c:w val="0.83005591971262449"/>
          <c:h val="0.49768081324297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225</c:f>
              <c:strCache>
                <c:ptCount val="1"/>
                <c:pt idx="0">
                  <c:v>1161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229:$D$236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E$229:$E$236</c:f>
              <c:numCache>
                <c:formatCode>0.00</c:formatCode>
                <c:ptCount val="8"/>
                <c:pt idx="0">
                  <c:v>0.56286615114040284</c:v>
                </c:pt>
                <c:pt idx="1">
                  <c:v>0.69630806890667218</c:v>
                </c:pt>
                <c:pt idx="2">
                  <c:v>0.62627674162998437</c:v>
                </c:pt>
                <c:pt idx="3">
                  <c:v>0.63074987094215063</c:v>
                </c:pt>
                <c:pt idx="4">
                  <c:v>0</c:v>
                </c:pt>
                <c:pt idx="5">
                  <c:v>0.65536913474438008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2"/>
          <c:order val="1"/>
          <c:tx>
            <c:strRef>
              <c:f>Reports!$G$228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rgbClr val="3333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229:$D$236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G$229:$G$236</c:f>
              <c:numCache>
                <c:formatCode>0.00</c:formatCode>
                <c:ptCount val="8"/>
                <c:pt idx="0">
                  <c:v>0.5136791012403441</c:v>
                </c:pt>
                <c:pt idx="1">
                  <c:v>0.61915187986224318</c:v>
                </c:pt>
                <c:pt idx="2">
                  <c:v>0.62061262118571436</c:v>
                </c:pt>
                <c:pt idx="3">
                  <c:v>0.59740154539010581</c:v>
                </c:pt>
                <c:pt idx="4">
                  <c:v>0</c:v>
                </c:pt>
                <c:pt idx="5">
                  <c:v>0.6164764296868455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765120"/>
        <c:axId val="128004096"/>
      </c:barChart>
      <c:catAx>
        <c:axId val="127765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/>
            </a:pPr>
            <a:endParaRPr lang="es-ES"/>
          </a:p>
        </c:txPr>
        <c:crossAx val="12800409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28004096"/>
        <c:scaling>
          <c:orientation val="minMax"/>
          <c:max val="1.8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s-ES"/>
          </a:p>
        </c:txPr>
        <c:crossAx val="127765120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81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70852275681993E-2"/>
          <c:y val="5.7356608478802994E-2"/>
          <c:w val="0.88797523209671858"/>
          <c:h val="0.715644533841343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2</c:f>
              <c:strCache>
                <c:ptCount val="1"/>
                <c:pt idx="0">
                  <c:v>1158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6:$D$13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E$6:$E$13</c:f>
              <c:numCache>
                <c:formatCode>0.00</c:formatCode>
                <c:ptCount val="8"/>
                <c:pt idx="0">
                  <c:v>0.80524568965794441</c:v>
                </c:pt>
                <c:pt idx="1">
                  <c:v>0.84311748999157321</c:v>
                </c:pt>
                <c:pt idx="2">
                  <c:v>0.79914154189794195</c:v>
                </c:pt>
                <c:pt idx="3">
                  <c:v>0.84659172227995294</c:v>
                </c:pt>
                <c:pt idx="4">
                  <c:v>0</c:v>
                </c:pt>
                <c:pt idx="5">
                  <c:v>0.8616487340900425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2"/>
          <c:order val="1"/>
          <c:tx>
            <c:strRef>
              <c:f>Reports!$G$5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rgbClr val="3333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6:$D$13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G$6:$G$13</c:f>
              <c:numCache>
                <c:formatCode>0.00</c:formatCode>
                <c:ptCount val="8"/>
                <c:pt idx="0">
                  <c:v>0.5136791012403441</c:v>
                </c:pt>
                <c:pt idx="1">
                  <c:v>0.61915187986224318</c:v>
                </c:pt>
                <c:pt idx="2">
                  <c:v>0.62061262118571436</c:v>
                </c:pt>
                <c:pt idx="3">
                  <c:v>0.59740154539010581</c:v>
                </c:pt>
                <c:pt idx="4">
                  <c:v>0</c:v>
                </c:pt>
                <c:pt idx="5">
                  <c:v>0.6164764296868455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146304"/>
        <c:axId val="136177536"/>
      </c:barChart>
      <c:catAx>
        <c:axId val="13614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/>
            </a:pPr>
            <a:endParaRPr lang="es-ES"/>
          </a:p>
        </c:txPr>
        <c:crossAx val="1361775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36177536"/>
        <c:scaling>
          <c:orientation val="minMax"/>
          <c:max val="1.8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s-ES"/>
          </a:p>
        </c:txPr>
        <c:crossAx val="136146304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8100">
      <a:solidFill>
        <a:srgbClr val="000000"/>
      </a:solidFill>
      <a:prstDash val="solid"/>
    </a:ln>
  </c:spPr>
  <c:txPr>
    <a:bodyPr/>
    <a:lstStyle/>
    <a:p>
      <a:pPr>
        <a:defRPr sz="6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s-ES" b="1" dirty="0" smtClean="0"/>
              <a:t>III-5</a:t>
            </a:r>
            <a:endParaRPr lang="es-ES" b="1" dirty="0"/>
          </a:p>
        </c:rich>
      </c:tx>
      <c:layout>
        <c:manualLayout>
          <c:xMode val="edge"/>
          <c:yMode val="edge"/>
          <c:x val="0.46748559332417799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9206541431325623E-2"/>
          <c:y val="7.3825624321033984E-2"/>
          <c:w val="0.87301756459566549"/>
          <c:h val="0.674497749478537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58</c:f>
              <c:strCache>
                <c:ptCount val="1"/>
                <c:pt idx="0">
                  <c:v>1159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B$62:$B$110</c:f>
              <c:strCache>
                <c:ptCount val="49"/>
                <c:pt idx="0">
                  <c:v>NIPA1 (BP1-BP2)</c:v>
                </c:pt>
                <c:pt idx="1">
                  <c:v>TUBGCP5 (BP1-BP2)</c:v>
                </c:pt>
                <c:pt idx="2">
                  <c:v>MKRN3 (exon1)</c:v>
                </c:pt>
                <c:pt idx="3">
                  <c:v>MAGEL2 (EXON1)</c:v>
                </c:pt>
                <c:pt idx="4">
                  <c:v>MAGEL2 (EXON 1)</c:v>
                </c:pt>
                <c:pt idx="5">
                  <c:v>NDN (exon1)</c:v>
                </c:pt>
                <c:pt idx="6">
                  <c:v>SNRPN (exon U1B)</c:v>
                </c:pt>
                <c:pt idx="7">
                  <c:v>SNRPN (exon U1B)</c:v>
                </c:pt>
                <c:pt idx="8">
                  <c:v>SNRPN (intron U2)</c:v>
                </c:pt>
                <c:pt idx="9">
                  <c:v>SNRPN (intron U2)</c:v>
                </c:pt>
                <c:pt idx="10">
                  <c:v>SNRPN (exonU5)</c:v>
                </c:pt>
                <c:pt idx="11">
                  <c:v>SNRPN (exonU5-AS-SRO)</c:v>
                </c:pt>
                <c:pt idx="12">
                  <c:v>SNRPN (exon3)</c:v>
                </c:pt>
                <c:pt idx="13">
                  <c:v>SNRPN (exon3)</c:v>
                </c:pt>
                <c:pt idx="14">
                  <c:v>SNRPN (intron3)</c:v>
                </c:pt>
                <c:pt idx="15">
                  <c:v>SNRPN (exon3)</c:v>
                </c:pt>
                <c:pt idx="16">
                  <c:v>SNURF-SNRPN (exon3)</c:v>
                </c:pt>
                <c:pt idx="17">
                  <c:v>SNRPN (Exon7)</c:v>
                </c:pt>
                <c:pt idx="18">
                  <c:v>SNRPN (SNORD116-1)</c:v>
                </c:pt>
                <c:pt idx="19">
                  <c:v>SNRPN  (SNORD116-11)</c:v>
                </c:pt>
                <c:pt idx="20">
                  <c:v>SNRPN  (SNORD116-23)</c:v>
                </c:pt>
                <c:pt idx="21">
                  <c:v>UBE3A (exon9)</c:v>
                </c:pt>
                <c:pt idx="22">
                  <c:v>UBE3A (exon4)</c:v>
                </c:pt>
                <c:pt idx="23">
                  <c:v>UBE3A (exon7)</c:v>
                </c:pt>
                <c:pt idx="24">
                  <c:v>UBE3A (exon2)</c:v>
                </c:pt>
                <c:pt idx="25">
                  <c:v>UBE3A (exon1)</c:v>
                </c:pt>
                <c:pt idx="26">
                  <c:v>UBE3A (exon1)</c:v>
                </c:pt>
                <c:pt idx="27">
                  <c:v>ATP10A (exon15)</c:v>
                </c:pt>
                <c:pt idx="28">
                  <c:v>ATP10A (exon1)</c:v>
                </c:pt>
                <c:pt idx="29">
                  <c:v>GABRB3</c:v>
                </c:pt>
                <c:pt idx="30">
                  <c:v>GABRB3</c:v>
                </c:pt>
                <c:pt idx="31">
                  <c:v>OCA2 (exon23)</c:v>
                </c:pt>
                <c:pt idx="32">
                  <c:v>OCA2 (exon3)</c:v>
                </c:pt>
                <c:pt idx="33">
                  <c:v>APBA2 (exon14)</c:v>
                </c:pt>
                <c:pt idx="34">
                  <c:v>1q23</c:v>
                </c:pt>
                <c:pt idx="35">
                  <c:v>2q12</c:v>
                </c:pt>
                <c:pt idx="36">
                  <c:v>4q12</c:v>
                </c:pt>
                <c:pt idx="37">
                  <c:v>5p15</c:v>
                </c:pt>
                <c:pt idx="38">
                  <c:v>5q31</c:v>
                </c:pt>
                <c:pt idx="39">
                  <c:v>6q24</c:v>
                </c:pt>
                <c:pt idx="40">
                  <c:v>7q21</c:v>
                </c:pt>
                <c:pt idx="41">
                  <c:v>8p21</c:v>
                </c:pt>
                <c:pt idx="42">
                  <c:v>10p11</c:v>
                </c:pt>
                <c:pt idx="43">
                  <c:v>11q24</c:v>
                </c:pt>
                <c:pt idx="44">
                  <c:v>12q13</c:v>
                </c:pt>
                <c:pt idx="45">
                  <c:v>17q12</c:v>
                </c:pt>
                <c:pt idx="46">
                  <c:v>21q22</c:v>
                </c:pt>
                <c:pt idx="47">
                  <c:v>X</c:v>
                </c:pt>
                <c:pt idx="48">
                  <c:v>Y</c:v>
                </c:pt>
              </c:strCache>
            </c:strRef>
          </c:cat>
          <c:val>
            <c:numRef>
              <c:f>Reports!$C$62:$C$110</c:f>
              <c:numCache>
                <c:formatCode>0.00</c:formatCode>
                <c:ptCount val="49"/>
                <c:pt idx="0">
                  <c:v>0.79059546031069017</c:v>
                </c:pt>
                <c:pt idx="1">
                  <c:v>1.1216584638617626</c:v>
                </c:pt>
                <c:pt idx="2">
                  <c:v>1.6476559079256894</c:v>
                </c:pt>
                <c:pt idx="3">
                  <c:v>1.3220465925913256</c:v>
                </c:pt>
                <c:pt idx="4">
                  <c:v>1.3631432779146411</c:v>
                </c:pt>
                <c:pt idx="5">
                  <c:v>1.2468694621006604</c:v>
                </c:pt>
                <c:pt idx="6">
                  <c:v>1.5683365260721673</c:v>
                </c:pt>
                <c:pt idx="7">
                  <c:v>1.5054976496711547</c:v>
                </c:pt>
                <c:pt idx="8">
                  <c:v>1.4335718302233733</c:v>
                </c:pt>
                <c:pt idx="9">
                  <c:v>1.4326131960610418</c:v>
                </c:pt>
                <c:pt idx="10">
                  <c:v>1.5073738884053998</c:v>
                </c:pt>
                <c:pt idx="11">
                  <c:v>1.3227423281711697</c:v>
                </c:pt>
                <c:pt idx="12">
                  <c:v>1.4752944740343561</c:v>
                </c:pt>
                <c:pt idx="13">
                  <c:v>1.530596731588713</c:v>
                </c:pt>
                <c:pt idx="14">
                  <c:v>1.4174846397921024</c:v>
                </c:pt>
                <c:pt idx="15">
                  <c:v>1.6239735293610842</c:v>
                </c:pt>
                <c:pt idx="16">
                  <c:v>1.5820102991631246</c:v>
                </c:pt>
                <c:pt idx="17">
                  <c:v>1.3641167753765351</c:v>
                </c:pt>
                <c:pt idx="18">
                  <c:v>1.5839202849686527</c:v>
                </c:pt>
                <c:pt idx="19">
                  <c:v>1.4422989442520806</c:v>
                </c:pt>
                <c:pt idx="20">
                  <c:v>1.5015386141087661</c:v>
                </c:pt>
                <c:pt idx="21">
                  <c:v>1.4240761997824529</c:v>
                </c:pt>
                <c:pt idx="22">
                  <c:v>1.4397003956662595</c:v>
                </c:pt>
                <c:pt idx="23">
                  <c:v>1.6311701561735275</c:v>
                </c:pt>
                <c:pt idx="24">
                  <c:v>1.6629897370843343</c:v>
                </c:pt>
                <c:pt idx="25">
                  <c:v>1.4141228737473062</c:v>
                </c:pt>
                <c:pt idx="26">
                  <c:v>1.3536574910678201</c:v>
                </c:pt>
                <c:pt idx="27">
                  <c:v>1.4541511776142935</c:v>
                </c:pt>
                <c:pt idx="28">
                  <c:v>1.3851191706817714</c:v>
                </c:pt>
                <c:pt idx="29">
                  <c:v>1.5573240386762679</c:v>
                </c:pt>
                <c:pt idx="30">
                  <c:v>1.4702374432015042</c:v>
                </c:pt>
                <c:pt idx="31">
                  <c:v>1.6142161004918649</c:v>
                </c:pt>
                <c:pt idx="32">
                  <c:v>1.4713617480206636</c:v>
                </c:pt>
                <c:pt idx="33">
                  <c:v>0.86972780191858157</c:v>
                </c:pt>
                <c:pt idx="34">
                  <c:v>0.85213162898533834</c:v>
                </c:pt>
                <c:pt idx="35">
                  <c:v>0.9635956377658067</c:v>
                </c:pt>
                <c:pt idx="36">
                  <c:v>1.0291120697901912</c:v>
                </c:pt>
                <c:pt idx="37">
                  <c:v>1.0494648360148504</c:v>
                </c:pt>
                <c:pt idx="38">
                  <c:v>1.110643393919063</c:v>
                </c:pt>
                <c:pt idx="39">
                  <c:v>0.9783630244371041</c:v>
                </c:pt>
                <c:pt idx="40">
                  <c:v>1.0549739012989561</c:v>
                </c:pt>
                <c:pt idx="41">
                  <c:v>0.78854586343619026</c:v>
                </c:pt>
                <c:pt idx="42">
                  <c:v>0.93887313317280852</c:v>
                </c:pt>
                <c:pt idx="43">
                  <c:v>1.0869273841139291</c:v>
                </c:pt>
                <c:pt idx="44">
                  <c:v>0.95549256329133248</c:v>
                </c:pt>
                <c:pt idx="45">
                  <c:v>1.1856185770151879</c:v>
                </c:pt>
                <c:pt idx="46">
                  <c:v>0.89575635356144467</c:v>
                </c:pt>
                <c:pt idx="47">
                  <c:v>1.2441638157684345</c:v>
                </c:pt>
                <c:pt idx="48">
                  <c:v>1.39803237853652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702336"/>
        <c:axId val="126703872"/>
      </c:barChart>
      <c:catAx>
        <c:axId val="126702336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26703872"/>
        <c:crosses val="autoZero"/>
        <c:auto val="1"/>
        <c:lblAlgn val="ctr"/>
        <c:lblOffset val="100"/>
        <c:tickMarkSkip val="1"/>
        <c:noMultiLvlLbl val="0"/>
      </c:catAx>
      <c:valAx>
        <c:axId val="126703872"/>
        <c:scaling>
          <c:orientation val="minMax"/>
          <c:max val="2"/>
          <c:min val="0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26702336"/>
        <c:crosses val="autoZero"/>
        <c:crossBetween val="between"/>
      </c:valAx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127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70852275681993E-2"/>
          <c:y val="5.7356608478802994E-2"/>
          <c:w val="0.85747731330154675"/>
          <c:h val="0.49768081324297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58</c:f>
              <c:strCache>
                <c:ptCount val="1"/>
                <c:pt idx="0">
                  <c:v>1159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62:$D$69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E$62:$E$69</c:f>
              <c:numCache>
                <c:formatCode>0.00</c:formatCode>
                <c:ptCount val="8"/>
                <c:pt idx="0">
                  <c:v>0.77642516025629515</c:v>
                </c:pt>
                <c:pt idx="1">
                  <c:v>0.87904561087397581</c:v>
                </c:pt>
                <c:pt idx="2">
                  <c:v>0.91587773887917678</c:v>
                </c:pt>
                <c:pt idx="3">
                  <c:v>0.84184921399248014</c:v>
                </c:pt>
                <c:pt idx="4">
                  <c:v>0</c:v>
                </c:pt>
                <c:pt idx="5">
                  <c:v>0.9478866896138826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2"/>
          <c:order val="1"/>
          <c:tx>
            <c:strRef>
              <c:f>Reports!$G$61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rgbClr val="3333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62:$D$69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G$62:$G$69</c:f>
              <c:numCache>
                <c:formatCode>0.00</c:formatCode>
                <c:ptCount val="8"/>
                <c:pt idx="0">
                  <c:v>0.5136791012403441</c:v>
                </c:pt>
                <c:pt idx="1">
                  <c:v>0.61915187986224318</c:v>
                </c:pt>
                <c:pt idx="2">
                  <c:v>0.62061262118571436</c:v>
                </c:pt>
                <c:pt idx="3">
                  <c:v>0.59740154539010581</c:v>
                </c:pt>
                <c:pt idx="4">
                  <c:v>0</c:v>
                </c:pt>
                <c:pt idx="5">
                  <c:v>0.6164764296868455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279744"/>
        <c:axId val="76051584"/>
      </c:barChart>
      <c:catAx>
        <c:axId val="75279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/>
            </a:pPr>
            <a:endParaRPr lang="es-ES"/>
          </a:p>
        </c:txPr>
        <c:crossAx val="7605158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76051584"/>
        <c:scaling>
          <c:orientation val="minMax"/>
          <c:max val="2.2000000000000002"/>
          <c:min val="0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s-ES"/>
          </a:p>
        </c:txPr>
        <c:crossAx val="75279744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81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s-ES" b="1" dirty="0" smtClean="0"/>
              <a:t>III-4</a:t>
            </a:r>
            <a:endParaRPr lang="es-ES" b="1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9.9206541431325623E-2"/>
          <c:y val="7.3825624321033984E-2"/>
          <c:w val="0.87301756459566549"/>
          <c:h val="0.674497749478537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114</c:f>
              <c:strCache>
                <c:ptCount val="1"/>
                <c:pt idx="0">
                  <c:v>1158-HA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B$118:$B$166</c:f>
              <c:strCache>
                <c:ptCount val="49"/>
                <c:pt idx="0">
                  <c:v>NIPA1 (BP1-BP2)</c:v>
                </c:pt>
                <c:pt idx="1">
                  <c:v>TUBGCP5 (BP1-BP2)</c:v>
                </c:pt>
                <c:pt idx="2">
                  <c:v>MKRN3 (exon1)</c:v>
                </c:pt>
                <c:pt idx="3">
                  <c:v>MAGEL2 (EXON1)</c:v>
                </c:pt>
                <c:pt idx="4">
                  <c:v>MAGEL2 (EXON 1)</c:v>
                </c:pt>
                <c:pt idx="5">
                  <c:v>NDN (exon1)</c:v>
                </c:pt>
                <c:pt idx="6">
                  <c:v>SNRPN (exon U1B)</c:v>
                </c:pt>
                <c:pt idx="7">
                  <c:v>SNRPN (exon U1B)</c:v>
                </c:pt>
                <c:pt idx="8">
                  <c:v>SNRPN (intron U2)</c:v>
                </c:pt>
                <c:pt idx="9">
                  <c:v>SNRPN (intron U2)</c:v>
                </c:pt>
                <c:pt idx="10">
                  <c:v>SNRPN (exonU5)</c:v>
                </c:pt>
                <c:pt idx="11">
                  <c:v>SNRPN (exonU5-AS-SRO)</c:v>
                </c:pt>
                <c:pt idx="12">
                  <c:v>SNRPN (exon3)</c:v>
                </c:pt>
                <c:pt idx="13">
                  <c:v>SNRPN (exon3)</c:v>
                </c:pt>
                <c:pt idx="14">
                  <c:v>SNRPN (intron3)</c:v>
                </c:pt>
                <c:pt idx="15">
                  <c:v>SNRPN (exon3)</c:v>
                </c:pt>
                <c:pt idx="16">
                  <c:v>SNURF-SNRPN (exon3)</c:v>
                </c:pt>
                <c:pt idx="17">
                  <c:v>SNRPN (Exon7)</c:v>
                </c:pt>
                <c:pt idx="18">
                  <c:v>SNRPN (SNORD116-1)</c:v>
                </c:pt>
                <c:pt idx="19">
                  <c:v>SNRPN  (SNORD116-11)</c:v>
                </c:pt>
                <c:pt idx="20">
                  <c:v>SNRPN  (SNORD116-23)</c:v>
                </c:pt>
                <c:pt idx="21">
                  <c:v>UBE3A (exon9)</c:v>
                </c:pt>
                <c:pt idx="22">
                  <c:v>UBE3A (exon4)</c:v>
                </c:pt>
                <c:pt idx="23">
                  <c:v>UBE3A (exon7)</c:v>
                </c:pt>
                <c:pt idx="24">
                  <c:v>UBE3A (exon2)</c:v>
                </c:pt>
                <c:pt idx="25">
                  <c:v>UBE3A (exon1)</c:v>
                </c:pt>
                <c:pt idx="26">
                  <c:v>UBE3A (exon1)</c:v>
                </c:pt>
                <c:pt idx="27">
                  <c:v>ATP10A (exon15)</c:v>
                </c:pt>
                <c:pt idx="28">
                  <c:v>ATP10A (exon1)</c:v>
                </c:pt>
                <c:pt idx="29">
                  <c:v>GABRB3</c:v>
                </c:pt>
                <c:pt idx="30">
                  <c:v>GABRB3</c:v>
                </c:pt>
                <c:pt idx="31">
                  <c:v>OCA2 (exon23)</c:v>
                </c:pt>
                <c:pt idx="32">
                  <c:v>OCA2 (exon3)</c:v>
                </c:pt>
                <c:pt idx="33">
                  <c:v>APBA2 (exon14)</c:v>
                </c:pt>
                <c:pt idx="34">
                  <c:v>1q23</c:v>
                </c:pt>
                <c:pt idx="35">
                  <c:v>2q12</c:v>
                </c:pt>
                <c:pt idx="36">
                  <c:v>4q12</c:v>
                </c:pt>
                <c:pt idx="37">
                  <c:v>5p15</c:v>
                </c:pt>
                <c:pt idx="38">
                  <c:v>5q31</c:v>
                </c:pt>
                <c:pt idx="39">
                  <c:v>6q24</c:v>
                </c:pt>
                <c:pt idx="40">
                  <c:v>7q21</c:v>
                </c:pt>
                <c:pt idx="41">
                  <c:v>8p21</c:v>
                </c:pt>
                <c:pt idx="42">
                  <c:v>10p11</c:v>
                </c:pt>
                <c:pt idx="43">
                  <c:v>11q24</c:v>
                </c:pt>
                <c:pt idx="44">
                  <c:v>12q13</c:v>
                </c:pt>
                <c:pt idx="45">
                  <c:v>17q12</c:v>
                </c:pt>
                <c:pt idx="46">
                  <c:v>21q22</c:v>
                </c:pt>
                <c:pt idx="47">
                  <c:v>X</c:v>
                </c:pt>
                <c:pt idx="48">
                  <c:v>Y</c:v>
                </c:pt>
              </c:strCache>
            </c:strRef>
          </c:cat>
          <c:val>
            <c:numRef>
              <c:f>Reports!$C$118:$C$166</c:f>
              <c:numCache>
                <c:formatCode>0.00</c:formatCode>
                <c:ptCount val="49"/>
                <c:pt idx="0">
                  <c:v>0.83278816878282869</c:v>
                </c:pt>
                <c:pt idx="1">
                  <c:v>0.96340099739960861</c:v>
                </c:pt>
                <c:pt idx="2">
                  <c:v>1.6873900586663371</c:v>
                </c:pt>
                <c:pt idx="3">
                  <c:v>1.4391457084166652</c:v>
                </c:pt>
                <c:pt idx="4">
                  <c:v>1.4184680853890708</c:v>
                </c:pt>
                <c:pt idx="5">
                  <c:v>1.3896210301371279</c:v>
                </c:pt>
                <c:pt idx="6">
                  <c:v>1.5384615365861702</c:v>
                </c:pt>
                <c:pt idx="7">
                  <c:v>1.4253143911355322</c:v>
                </c:pt>
                <c:pt idx="8">
                  <c:v>1.3900254945482216</c:v>
                </c:pt>
                <c:pt idx="9">
                  <c:v>1.3691271634314424</c:v>
                </c:pt>
                <c:pt idx="10">
                  <c:v>1.5165843546395308</c:v>
                </c:pt>
                <c:pt idx="11">
                  <c:v>1.3558431591403133</c:v>
                </c:pt>
                <c:pt idx="12">
                  <c:v>1.5166691153428262</c:v>
                </c:pt>
                <c:pt idx="13">
                  <c:v>1.432499713973467</c:v>
                </c:pt>
                <c:pt idx="14">
                  <c:v>1.4443370184800262</c:v>
                </c:pt>
                <c:pt idx="15">
                  <c:v>1.4713055772241319</c:v>
                </c:pt>
                <c:pt idx="16">
                  <c:v>1.521520281927379</c:v>
                </c:pt>
                <c:pt idx="17">
                  <c:v>1.4656722015061625</c:v>
                </c:pt>
                <c:pt idx="18">
                  <c:v>1.4713570760581531</c:v>
                </c:pt>
                <c:pt idx="19">
                  <c:v>1.4593766744144134</c:v>
                </c:pt>
                <c:pt idx="20">
                  <c:v>1.5312145222687839</c:v>
                </c:pt>
                <c:pt idx="21">
                  <c:v>1.5358637888833235</c:v>
                </c:pt>
                <c:pt idx="22">
                  <c:v>1.4550629176361709</c:v>
                </c:pt>
                <c:pt idx="23">
                  <c:v>1.4577761635830593</c:v>
                </c:pt>
                <c:pt idx="24">
                  <c:v>1.5068904868047621</c:v>
                </c:pt>
                <c:pt idx="25">
                  <c:v>1.502357170499879</c:v>
                </c:pt>
                <c:pt idx="26">
                  <c:v>1.3611746356425065</c:v>
                </c:pt>
                <c:pt idx="27">
                  <c:v>1.4934270188853322</c:v>
                </c:pt>
                <c:pt idx="28">
                  <c:v>1.4551310618579383</c:v>
                </c:pt>
                <c:pt idx="29">
                  <c:v>1.4504980654342434</c:v>
                </c:pt>
                <c:pt idx="30">
                  <c:v>1.5234574398382632</c:v>
                </c:pt>
                <c:pt idx="31">
                  <c:v>1.564828392258393</c:v>
                </c:pt>
                <c:pt idx="32">
                  <c:v>1.5258381402574435</c:v>
                </c:pt>
                <c:pt idx="33">
                  <c:v>0.92678192912456703</c:v>
                </c:pt>
                <c:pt idx="34">
                  <c:v>0.97290483445291864</c:v>
                </c:pt>
                <c:pt idx="35">
                  <c:v>0.99055527122757303</c:v>
                </c:pt>
                <c:pt idx="36">
                  <c:v>1.0373246940604863</c:v>
                </c:pt>
                <c:pt idx="37">
                  <c:v>0.99984361230873764</c:v>
                </c:pt>
                <c:pt idx="38">
                  <c:v>1.0627279642975391</c:v>
                </c:pt>
                <c:pt idx="39">
                  <c:v>0.97733959033554951</c:v>
                </c:pt>
                <c:pt idx="40">
                  <c:v>0.99395223106055453</c:v>
                </c:pt>
                <c:pt idx="41">
                  <c:v>0.92128461252437821</c:v>
                </c:pt>
                <c:pt idx="42">
                  <c:v>0.98059835962433417</c:v>
                </c:pt>
                <c:pt idx="43">
                  <c:v>1.0074414872030033</c:v>
                </c:pt>
                <c:pt idx="44">
                  <c:v>0.95536130466694758</c:v>
                </c:pt>
                <c:pt idx="45">
                  <c:v>1.0568729965950325</c:v>
                </c:pt>
                <c:pt idx="46">
                  <c:v>1.0045486777775443</c:v>
                </c:pt>
                <c:pt idx="47">
                  <c:v>1.9177272081626537</c:v>
                </c:pt>
                <c:pt idx="48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509248"/>
        <c:axId val="127510784"/>
      </c:barChart>
      <c:catAx>
        <c:axId val="127509248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27510784"/>
        <c:crosses val="autoZero"/>
        <c:auto val="1"/>
        <c:lblAlgn val="ctr"/>
        <c:lblOffset val="100"/>
        <c:tickMarkSkip val="1"/>
        <c:noMultiLvlLbl val="0"/>
      </c:catAx>
      <c:valAx>
        <c:axId val="127510784"/>
        <c:scaling>
          <c:orientation val="minMax"/>
          <c:max val="2"/>
          <c:min val="0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27509248"/>
        <c:crosses val="autoZero"/>
        <c:crossBetween val="between"/>
      </c:valAx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127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206304415061185E-2"/>
          <c:y val="5.7356608478802994E-2"/>
          <c:w val="0.87037352885181651"/>
          <c:h val="0.571638759738991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114</c:f>
              <c:strCache>
                <c:ptCount val="1"/>
                <c:pt idx="0">
                  <c:v>1158-HA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118:$D$125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E$118:$E$125</c:f>
              <c:numCache>
                <c:formatCode>0.00</c:formatCode>
                <c:ptCount val="8"/>
                <c:pt idx="0">
                  <c:v>0.83343530195625892</c:v>
                </c:pt>
                <c:pt idx="1">
                  <c:v>1.0033223154320052</c:v>
                </c:pt>
                <c:pt idx="2">
                  <c:v>0.94147209260817455</c:v>
                </c:pt>
                <c:pt idx="3">
                  <c:v>0.80281748808814768</c:v>
                </c:pt>
                <c:pt idx="4">
                  <c:v>0</c:v>
                </c:pt>
                <c:pt idx="5">
                  <c:v>0.87985992469217233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2"/>
          <c:order val="1"/>
          <c:tx>
            <c:strRef>
              <c:f>Reports!$G$117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rgbClr val="3333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118:$D$125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G$118:$G$125</c:f>
              <c:numCache>
                <c:formatCode>0.00</c:formatCode>
                <c:ptCount val="8"/>
                <c:pt idx="0">
                  <c:v>0.5136791012403441</c:v>
                </c:pt>
                <c:pt idx="1">
                  <c:v>0.61915187986224318</c:v>
                </c:pt>
                <c:pt idx="2">
                  <c:v>0.62061262118571436</c:v>
                </c:pt>
                <c:pt idx="3">
                  <c:v>0.59740154539010581</c:v>
                </c:pt>
                <c:pt idx="4">
                  <c:v>0</c:v>
                </c:pt>
                <c:pt idx="5">
                  <c:v>0.6164764296868455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981184"/>
        <c:axId val="99982720"/>
      </c:barChart>
      <c:catAx>
        <c:axId val="99981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/>
            </a:pPr>
            <a:endParaRPr lang="es-ES"/>
          </a:p>
        </c:txPr>
        <c:crossAx val="9998272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99982720"/>
        <c:scaling>
          <c:orientation val="minMax"/>
          <c:max val="1.8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s-ES"/>
          </a:p>
        </c:txPr>
        <c:crossAx val="99981184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81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s-ES" b="1" dirty="0" smtClean="0"/>
              <a:t>II-6</a:t>
            </a:r>
            <a:endParaRPr lang="es-ES" b="1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9.9206541431325623E-2"/>
          <c:y val="7.3825624321033984E-2"/>
          <c:w val="0.87301756459566549"/>
          <c:h val="0.674497749478537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170</c:f>
              <c:strCache>
                <c:ptCount val="1"/>
                <c:pt idx="0">
                  <c:v>1160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B$174:$B$222</c:f>
              <c:strCache>
                <c:ptCount val="49"/>
                <c:pt idx="0">
                  <c:v>NIPA1 (BP1-BP2)</c:v>
                </c:pt>
                <c:pt idx="1">
                  <c:v>TUBGCP5 (BP1-BP2)</c:v>
                </c:pt>
                <c:pt idx="2">
                  <c:v>MKRN3 (exon1)</c:v>
                </c:pt>
                <c:pt idx="3">
                  <c:v>MAGEL2 (EXON1)</c:v>
                </c:pt>
                <c:pt idx="4">
                  <c:v>MAGEL2 (EXON 1)</c:v>
                </c:pt>
                <c:pt idx="5">
                  <c:v>NDN (exon1)</c:v>
                </c:pt>
                <c:pt idx="6">
                  <c:v>SNRPN (exon U1B)</c:v>
                </c:pt>
                <c:pt idx="7">
                  <c:v>SNRPN (exon U1B)</c:v>
                </c:pt>
                <c:pt idx="8">
                  <c:v>SNRPN (intron U2)</c:v>
                </c:pt>
                <c:pt idx="9">
                  <c:v>SNRPN (intron U2)</c:v>
                </c:pt>
                <c:pt idx="10">
                  <c:v>SNRPN (exonU5)</c:v>
                </c:pt>
                <c:pt idx="11">
                  <c:v>SNRPN (exonU5-AS-SRO)</c:v>
                </c:pt>
                <c:pt idx="12">
                  <c:v>SNRPN (exon3)</c:v>
                </c:pt>
                <c:pt idx="13">
                  <c:v>SNRPN (exon3)</c:v>
                </c:pt>
                <c:pt idx="14">
                  <c:v>SNRPN (intron3)</c:v>
                </c:pt>
                <c:pt idx="15">
                  <c:v>SNRPN (exon3)</c:v>
                </c:pt>
                <c:pt idx="16">
                  <c:v>SNURF-SNRPN (exon3)</c:v>
                </c:pt>
                <c:pt idx="17">
                  <c:v>SNRPN (Exon7)</c:v>
                </c:pt>
                <c:pt idx="18">
                  <c:v>SNRPN (SNORD116-1)</c:v>
                </c:pt>
                <c:pt idx="19">
                  <c:v>SNRPN  (SNORD116-11)</c:v>
                </c:pt>
                <c:pt idx="20">
                  <c:v>SNRPN  (SNORD116-23)</c:v>
                </c:pt>
                <c:pt idx="21">
                  <c:v>UBE3A (exon9)</c:v>
                </c:pt>
                <c:pt idx="22">
                  <c:v>UBE3A (exon4)</c:v>
                </c:pt>
                <c:pt idx="23">
                  <c:v>UBE3A (exon7)</c:v>
                </c:pt>
                <c:pt idx="24">
                  <c:v>UBE3A (exon2)</c:v>
                </c:pt>
                <c:pt idx="25">
                  <c:v>UBE3A (exon1)</c:v>
                </c:pt>
                <c:pt idx="26">
                  <c:v>UBE3A (exon1)</c:v>
                </c:pt>
                <c:pt idx="27">
                  <c:v>ATP10A (exon15)</c:v>
                </c:pt>
                <c:pt idx="28">
                  <c:v>ATP10A (exon1)</c:v>
                </c:pt>
                <c:pt idx="29">
                  <c:v>GABRB3</c:v>
                </c:pt>
                <c:pt idx="30">
                  <c:v>GABRB3</c:v>
                </c:pt>
                <c:pt idx="31">
                  <c:v>OCA2 (exon23)</c:v>
                </c:pt>
                <c:pt idx="32">
                  <c:v>OCA2 (exon3)</c:v>
                </c:pt>
                <c:pt idx="33">
                  <c:v>APBA2 (exon14)</c:v>
                </c:pt>
                <c:pt idx="34">
                  <c:v>1q23</c:v>
                </c:pt>
                <c:pt idx="35">
                  <c:v>2q12</c:v>
                </c:pt>
                <c:pt idx="36">
                  <c:v>4q12</c:v>
                </c:pt>
                <c:pt idx="37">
                  <c:v>5p15</c:v>
                </c:pt>
                <c:pt idx="38">
                  <c:v>5q31</c:v>
                </c:pt>
                <c:pt idx="39">
                  <c:v>6q24</c:v>
                </c:pt>
                <c:pt idx="40">
                  <c:v>7q21</c:v>
                </c:pt>
                <c:pt idx="41">
                  <c:v>8p21</c:v>
                </c:pt>
                <c:pt idx="42">
                  <c:v>10p11</c:v>
                </c:pt>
                <c:pt idx="43">
                  <c:v>11q24</c:v>
                </c:pt>
                <c:pt idx="44">
                  <c:v>12q13</c:v>
                </c:pt>
                <c:pt idx="45">
                  <c:v>17q12</c:v>
                </c:pt>
                <c:pt idx="46">
                  <c:v>21q22</c:v>
                </c:pt>
                <c:pt idx="47">
                  <c:v>X</c:v>
                </c:pt>
                <c:pt idx="48">
                  <c:v>Y</c:v>
                </c:pt>
              </c:strCache>
            </c:strRef>
          </c:cat>
          <c:val>
            <c:numRef>
              <c:f>Reports!$C$174:$C$222</c:f>
              <c:numCache>
                <c:formatCode>0.00</c:formatCode>
                <c:ptCount val="49"/>
                <c:pt idx="0">
                  <c:v>0.93787316427645762</c:v>
                </c:pt>
                <c:pt idx="1">
                  <c:v>1.0230295032916186</c:v>
                </c:pt>
                <c:pt idx="2">
                  <c:v>1.6058945338431945</c:v>
                </c:pt>
                <c:pt idx="3">
                  <c:v>1.4911253612564266</c:v>
                </c:pt>
                <c:pt idx="4">
                  <c:v>1.4468698469041341</c:v>
                </c:pt>
                <c:pt idx="5">
                  <c:v>1.4431050316058518</c:v>
                </c:pt>
                <c:pt idx="6">
                  <c:v>1.5862928530405516</c:v>
                </c:pt>
                <c:pt idx="7">
                  <c:v>1.5064856827508213</c:v>
                </c:pt>
                <c:pt idx="8">
                  <c:v>1.5083414394524128</c:v>
                </c:pt>
                <c:pt idx="9">
                  <c:v>1.4383920153946532</c:v>
                </c:pt>
                <c:pt idx="10">
                  <c:v>1.472488046440855</c:v>
                </c:pt>
                <c:pt idx="11">
                  <c:v>1.3182729919788743</c:v>
                </c:pt>
                <c:pt idx="12">
                  <c:v>1.4746750839060776</c:v>
                </c:pt>
                <c:pt idx="13">
                  <c:v>1.4702286917520373</c:v>
                </c:pt>
                <c:pt idx="14">
                  <c:v>1.518712881074167</c:v>
                </c:pt>
                <c:pt idx="15">
                  <c:v>1.626928276770548</c:v>
                </c:pt>
                <c:pt idx="16">
                  <c:v>1.58814361157258</c:v>
                </c:pt>
                <c:pt idx="17">
                  <c:v>1.4476456473577966</c:v>
                </c:pt>
                <c:pt idx="18">
                  <c:v>1.5104925023071161</c:v>
                </c:pt>
                <c:pt idx="19">
                  <c:v>1.4420099034490099</c:v>
                </c:pt>
                <c:pt idx="20">
                  <c:v>1.5445717632598339</c:v>
                </c:pt>
                <c:pt idx="21">
                  <c:v>1.5769428375888759</c:v>
                </c:pt>
                <c:pt idx="22">
                  <c:v>1.5029463847709026</c:v>
                </c:pt>
                <c:pt idx="23">
                  <c:v>1.4697094494308542</c:v>
                </c:pt>
                <c:pt idx="24">
                  <c:v>1.5304463588425525</c:v>
                </c:pt>
                <c:pt idx="25">
                  <c:v>1.4532777887523312</c:v>
                </c:pt>
                <c:pt idx="26">
                  <c:v>1.3718247466032474</c:v>
                </c:pt>
                <c:pt idx="27">
                  <c:v>1.4934885383051193</c:v>
                </c:pt>
                <c:pt idx="28">
                  <c:v>1.504668891491606</c:v>
                </c:pt>
                <c:pt idx="29">
                  <c:v>1.5001270546102921</c:v>
                </c:pt>
                <c:pt idx="30">
                  <c:v>1.4890076041448062</c:v>
                </c:pt>
                <c:pt idx="31">
                  <c:v>1.5224186410248042</c:v>
                </c:pt>
                <c:pt idx="32">
                  <c:v>1.510768670766824</c:v>
                </c:pt>
                <c:pt idx="33">
                  <c:v>0.94817850261009384</c:v>
                </c:pt>
                <c:pt idx="34">
                  <c:v>0.96854134596679331</c:v>
                </c:pt>
                <c:pt idx="35">
                  <c:v>1.0191586168198565</c:v>
                </c:pt>
                <c:pt idx="36">
                  <c:v>1.0632713093691308</c:v>
                </c:pt>
                <c:pt idx="37">
                  <c:v>1.0976193656701134</c:v>
                </c:pt>
                <c:pt idx="38">
                  <c:v>1.0159611532327066</c:v>
                </c:pt>
                <c:pt idx="39">
                  <c:v>0.97334263729101167</c:v>
                </c:pt>
                <c:pt idx="40">
                  <c:v>0.94567122650073354</c:v>
                </c:pt>
                <c:pt idx="41">
                  <c:v>0.89888268689408812</c:v>
                </c:pt>
                <c:pt idx="42">
                  <c:v>0.99107872425421839</c:v>
                </c:pt>
                <c:pt idx="43">
                  <c:v>1.0321502351168497</c:v>
                </c:pt>
                <c:pt idx="44">
                  <c:v>0.98382889613373992</c:v>
                </c:pt>
                <c:pt idx="45">
                  <c:v>1.0546232752873164</c:v>
                </c:pt>
                <c:pt idx="46">
                  <c:v>0.91110906282062099</c:v>
                </c:pt>
                <c:pt idx="47">
                  <c:v>1.9520660787833162</c:v>
                </c:pt>
                <c:pt idx="48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735040"/>
        <c:axId val="75736576"/>
      </c:barChart>
      <c:catAx>
        <c:axId val="75735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75736576"/>
        <c:crosses val="autoZero"/>
        <c:auto val="1"/>
        <c:lblAlgn val="ctr"/>
        <c:lblOffset val="100"/>
        <c:tickMarkSkip val="1"/>
        <c:noMultiLvlLbl val="0"/>
      </c:catAx>
      <c:valAx>
        <c:axId val="75736576"/>
        <c:scaling>
          <c:orientation val="minMax"/>
          <c:max val="2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75735040"/>
        <c:crosses val="autoZero"/>
        <c:crossBetween val="between"/>
      </c:valAx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127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334677419354839E-2"/>
          <c:y val="5.336426914153132E-2"/>
          <c:w val="0.91662483625523672"/>
          <c:h val="0.541883487378150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170</c:f>
              <c:strCache>
                <c:ptCount val="1"/>
                <c:pt idx="0">
                  <c:v>1160</c:v>
                </c:pt>
              </c:strCache>
            </c:strRef>
          </c:tx>
          <c:spPr>
            <a:solidFill>
              <a:srgbClr val="CC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174:$D$181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E$174:$E$181</c:f>
              <c:numCache>
                <c:formatCode>0.00</c:formatCode>
                <c:ptCount val="8"/>
                <c:pt idx="0">
                  <c:v>0.37289760871752103</c:v>
                </c:pt>
                <c:pt idx="1">
                  <c:v>0.50405916566622144</c:v>
                </c:pt>
                <c:pt idx="2">
                  <c:v>0.47309513632476508</c:v>
                </c:pt>
                <c:pt idx="3">
                  <c:v>0.44714129813186038</c:v>
                </c:pt>
                <c:pt idx="4">
                  <c:v>0</c:v>
                </c:pt>
                <c:pt idx="5">
                  <c:v>0.48293061256747433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2"/>
          <c:order val="1"/>
          <c:tx>
            <c:strRef>
              <c:f>Reports!$G$173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rgbClr val="333399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D$174:$D$181</c:f>
              <c:strCache>
                <c:ptCount val="8"/>
                <c:pt idx="0">
                  <c:v>SNRPN (exon3)</c:v>
                </c:pt>
                <c:pt idx="1">
                  <c:v>SNRPN (exon3)</c:v>
                </c:pt>
                <c:pt idx="2">
                  <c:v>SNRPN (intron3)</c:v>
                </c:pt>
                <c:pt idx="3">
                  <c:v>SNRPN (exon3)</c:v>
                </c:pt>
                <c:pt idx="4">
                  <c:v>UBE3A (exon1)</c:v>
                </c:pt>
                <c:pt idx="5">
                  <c:v>MAGEL2 (EXON 1)</c:v>
                </c:pt>
                <c:pt idx="6">
                  <c:v>2q12</c:v>
                </c:pt>
                <c:pt idx="7">
                  <c:v>21q22</c:v>
                </c:pt>
              </c:strCache>
            </c:strRef>
          </c:cat>
          <c:val>
            <c:numRef>
              <c:f>Reports!$G$174:$G$181</c:f>
              <c:numCache>
                <c:formatCode>0.00</c:formatCode>
                <c:ptCount val="8"/>
                <c:pt idx="0">
                  <c:v>0.5136791012403441</c:v>
                </c:pt>
                <c:pt idx="1">
                  <c:v>0.61915187986224318</c:v>
                </c:pt>
                <c:pt idx="2">
                  <c:v>0.62061262118571436</c:v>
                </c:pt>
                <c:pt idx="3">
                  <c:v>0.59740154539010581</c:v>
                </c:pt>
                <c:pt idx="4">
                  <c:v>0</c:v>
                </c:pt>
                <c:pt idx="5">
                  <c:v>0.6164764296868455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6978944"/>
        <c:axId val="66980480"/>
      </c:barChart>
      <c:catAx>
        <c:axId val="66978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/>
            </a:pPr>
            <a:endParaRPr lang="es-ES"/>
          </a:p>
        </c:txPr>
        <c:crossAx val="6698048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66980480"/>
        <c:scaling>
          <c:orientation val="minMax"/>
          <c:max val="1.8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s-ES"/>
          </a:p>
        </c:txPr>
        <c:crossAx val="66978944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81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1"/>
            </a:pPr>
            <a:r>
              <a:rPr lang="es-ES" b="1" dirty="0" smtClean="0"/>
              <a:t>II-5</a:t>
            </a:r>
            <a:endParaRPr lang="es-ES" b="1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9.9206541431325623E-2"/>
          <c:y val="7.3825624321033984E-2"/>
          <c:w val="0.87301756459566549"/>
          <c:h val="0.674497749478537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ports!$A$225</c:f>
              <c:strCache>
                <c:ptCount val="1"/>
                <c:pt idx="0">
                  <c:v>1161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Reports!$B$229:$B$277</c:f>
              <c:strCache>
                <c:ptCount val="49"/>
                <c:pt idx="0">
                  <c:v>NIPA1 (BP1-BP2)</c:v>
                </c:pt>
                <c:pt idx="1">
                  <c:v>TUBGCP5 (BP1-BP2)</c:v>
                </c:pt>
                <c:pt idx="2">
                  <c:v>MKRN3 (exon1)</c:v>
                </c:pt>
                <c:pt idx="3">
                  <c:v>MAGEL2 (EXON1)</c:v>
                </c:pt>
                <c:pt idx="4">
                  <c:v>MAGEL2 (EXON 1)</c:v>
                </c:pt>
                <c:pt idx="5">
                  <c:v>NDN (exon1)</c:v>
                </c:pt>
                <c:pt idx="6">
                  <c:v>SNRPN (exon U1B)</c:v>
                </c:pt>
                <c:pt idx="7">
                  <c:v>SNRPN (exon U1B)</c:v>
                </c:pt>
                <c:pt idx="8">
                  <c:v>SNRPN (intron U2)</c:v>
                </c:pt>
                <c:pt idx="9">
                  <c:v>SNRPN (intron U2)</c:v>
                </c:pt>
                <c:pt idx="10">
                  <c:v>SNRPN (exonU5)</c:v>
                </c:pt>
                <c:pt idx="11">
                  <c:v>SNRPN (exonU5-AS-SRO)</c:v>
                </c:pt>
                <c:pt idx="12">
                  <c:v>SNRPN (exon3)</c:v>
                </c:pt>
                <c:pt idx="13">
                  <c:v>SNRPN (exon3)</c:v>
                </c:pt>
                <c:pt idx="14">
                  <c:v>SNRPN (intron3)</c:v>
                </c:pt>
                <c:pt idx="15">
                  <c:v>SNRPN (exon3)</c:v>
                </c:pt>
                <c:pt idx="16">
                  <c:v>SNURF-SNRPN (exon3)</c:v>
                </c:pt>
                <c:pt idx="17">
                  <c:v>SNRPN (Exon7)</c:v>
                </c:pt>
                <c:pt idx="18">
                  <c:v>SNRPN (SNORD116-1)</c:v>
                </c:pt>
                <c:pt idx="19">
                  <c:v>SNRPN  (SNORD116-11)</c:v>
                </c:pt>
                <c:pt idx="20">
                  <c:v>SNRPN  (SNORD116-23)</c:v>
                </c:pt>
                <c:pt idx="21">
                  <c:v>UBE3A (exon9)</c:v>
                </c:pt>
                <c:pt idx="22">
                  <c:v>UBE3A (exon4)</c:v>
                </c:pt>
                <c:pt idx="23">
                  <c:v>UBE3A (exon7)</c:v>
                </c:pt>
                <c:pt idx="24">
                  <c:v>UBE3A (exon2)</c:v>
                </c:pt>
                <c:pt idx="25">
                  <c:v>UBE3A (exon1)</c:v>
                </c:pt>
                <c:pt idx="26">
                  <c:v>UBE3A (exon1)</c:v>
                </c:pt>
                <c:pt idx="27">
                  <c:v>ATP10A (exon15)</c:v>
                </c:pt>
                <c:pt idx="28">
                  <c:v>ATP10A (exon1)</c:v>
                </c:pt>
                <c:pt idx="29">
                  <c:v>GABRB3</c:v>
                </c:pt>
                <c:pt idx="30">
                  <c:v>GABRB3</c:v>
                </c:pt>
                <c:pt idx="31">
                  <c:v>OCA2 (exon23)</c:v>
                </c:pt>
                <c:pt idx="32">
                  <c:v>OCA2 (exon3)</c:v>
                </c:pt>
                <c:pt idx="33">
                  <c:v>APBA2 (exon14)</c:v>
                </c:pt>
                <c:pt idx="34">
                  <c:v>1q23</c:v>
                </c:pt>
                <c:pt idx="35">
                  <c:v>2q12</c:v>
                </c:pt>
                <c:pt idx="36">
                  <c:v>4q12</c:v>
                </c:pt>
                <c:pt idx="37">
                  <c:v>5p15</c:v>
                </c:pt>
                <c:pt idx="38">
                  <c:v>5q31</c:v>
                </c:pt>
                <c:pt idx="39">
                  <c:v>6q24</c:v>
                </c:pt>
                <c:pt idx="40">
                  <c:v>7q21</c:v>
                </c:pt>
                <c:pt idx="41">
                  <c:v>8p21</c:v>
                </c:pt>
                <c:pt idx="42">
                  <c:v>10p11</c:v>
                </c:pt>
                <c:pt idx="43">
                  <c:v>11q24</c:v>
                </c:pt>
                <c:pt idx="44">
                  <c:v>12q13</c:v>
                </c:pt>
                <c:pt idx="45">
                  <c:v>17q12</c:v>
                </c:pt>
                <c:pt idx="46">
                  <c:v>21q22</c:v>
                </c:pt>
                <c:pt idx="47">
                  <c:v>X</c:v>
                </c:pt>
                <c:pt idx="48">
                  <c:v>Y</c:v>
                </c:pt>
              </c:strCache>
            </c:strRef>
          </c:cat>
          <c:val>
            <c:numRef>
              <c:f>Reports!$C$229:$C$277</c:f>
              <c:numCache>
                <c:formatCode>0.00</c:formatCode>
                <c:ptCount val="49"/>
                <c:pt idx="0">
                  <c:v>0.8585211173014653</c:v>
                </c:pt>
                <c:pt idx="1">
                  <c:v>1.1222835884273621</c:v>
                </c:pt>
                <c:pt idx="2">
                  <c:v>1.1873474750004083</c:v>
                </c:pt>
                <c:pt idx="3">
                  <c:v>0.97245101011970836</c:v>
                </c:pt>
                <c:pt idx="4">
                  <c:v>1.0753314089639823</c:v>
                </c:pt>
                <c:pt idx="5">
                  <c:v>0.92273566517953254</c:v>
                </c:pt>
                <c:pt idx="6">
                  <c:v>1.0380896396650416</c:v>
                </c:pt>
                <c:pt idx="7">
                  <c:v>1.0390249095160791</c:v>
                </c:pt>
                <c:pt idx="8">
                  <c:v>0.99999438221296721</c:v>
                </c:pt>
                <c:pt idx="9">
                  <c:v>1.096686632158544</c:v>
                </c:pt>
                <c:pt idx="10">
                  <c:v>1.0934696353533453</c:v>
                </c:pt>
                <c:pt idx="11">
                  <c:v>0.90218490868190448</c:v>
                </c:pt>
                <c:pt idx="12">
                  <c:v>1.0252490841008901</c:v>
                </c:pt>
                <c:pt idx="13">
                  <c:v>1.0865304498638628</c:v>
                </c:pt>
                <c:pt idx="14">
                  <c:v>1.0938552728741187</c:v>
                </c:pt>
                <c:pt idx="15">
                  <c:v>1.2032272813565026</c:v>
                </c:pt>
                <c:pt idx="16">
                  <c:v>1.0464264774675227</c:v>
                </c:pt>
                <c:pt idx="17">
                  <c:v>0.86553610029995598</c:v>
                </c:pt>
                <c:pt idx="18">
                  <c:v>1.0845346015871067</c:v>
                </c:pt>
                <c:pt idx="19">
                  <c:v>0.93325636899402886</c:v>
                </c:pt>
                <c:pt idx="20">
                  <c:v>0.99813290174205582</c:v>
                </c:pt>
                <c:pt idx="21">
                  <c:v>0.96803278290183015</c:v>
                </c:pt>
                <c:pt idx="22">
                  <c:v>0.96645707850272577</c:v>
                </c:pt>
                <c:pt idx="23">
                  <c:v>1.0903173931572061</c:v>
                </c:pt>
                <c:pt idx="24">
                  <c:v>1.1037887831270241</c:v>
                </c:pt>
                <c:pt idx="25">
                  <c:v>0.94083579388223182</c:v>
                </c:pt>
                <c:pt idx="26">
                  <c:v>1.0648476691107303</c:v>
                </c:pt>
                <c:pt idx="27">
                  <c:v>0.9647869315618135</c:v>
                </c:pt>
                <c:pt idx="28">
                  <c:v>1.0886980901331473</c:v>
                </c:pt>
                <c:pt idx="29">
                  <c:v>1.0058180565167227</c:v>
                </c:pt>
                <c:pt idx="30">
                  <c:v>1.0269530281382453</c:v>
                </c:pt>
                <c:pt idx="31">
                  <c:v>1.1886182026078238</c:v>
                </c:pt>
                <c:pt idx="32">
                  <c:v>0.97675689928812115</c:v>
                </c:pt>
                <c:pt idx="33">
                  <c:v>1.0861940200015792</c:v>
                </c:pt>
                <c:pt idx="34">
                  <c:v>0.86986241165455958</c:v>
                </c:pt>
                <c:pt idx="35">
                  <c:v>0.95321771366942054</c:v>
                </c:pt>
                <c:pt idx="36">
                  <c:v>1.0959317367603394</c:v>
                </c:pt>
                <c:pt idx="37">
                  <c:v>1.0501126829113379</c:v>
                </c:pt>
                <c:pt idx="38">
                  <c:v>1.1791854545622555</c:v>
                </c:pt>
                <c:pt idx="39">
                  <c:v>0.89939832442703993</c:v>
                </c:pt>
                <c:pt idx="40">
                  <c:v>0.9006729392623537</c:v>
                </c:pt>
                <c:pt idx="41">
                  <c:v>0.78973605152675541</c:v>
                </c:pt>
                <c:pt idx="42">
                  <c:v>0.90004725250852491</c:v>
                </c:pt>
                <c:pt idx="43">
                  <c:v>1.1681546894673445</c:v>
                </c:pt>
                <c:pt idx="44">
                  <c:v>1.0559897765259179</c:v>
                </c:pt>
                <c:pt idx="45">
                  <c:v>1.1167163272533596</c:v>
                </c:pt>
                <c:pt idx="46">
                  <c:v>0.87723575575438562</c:v>
                </c:pt>
                <c:pt idx="47">
                  <c:v>1.1806323464078474</c:v>
                </c:pt>
                <c:pt idx="48">
                  <c:v>1.25492577435855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969152"/>
        <c:axId val="127779968"/>
      </c:barChart>
      <c:catAx>
        <c:axId val="85969152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127779968"/>
        <c:crosses val="autoZero"/>
        <c:auto val="1"/>
        <c:lblAlgn val="ctr"/>
        <c:lblOffset val="100"/>
        <c:tickMarkSkip val="1"/>
        <c:noMultiLvlLbl val="0"/>
      </c:catAx>
      <c:valAx>
        <c:axId val="127779968"/>
        <c:scaling>
          <c:orientation val="minMax"/>
          <c:max val="2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5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s-ES"/>
          </a:p>
        </c:txPr>
        <c:crossAx val="85969152"/>
        <c:crosses val="autoZero"/>
        <c:crossBetween val="between"/>
      </c:valAx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12700">
      <a:solidFill>
        <a:srgbClr val="000000"/>
      </a:solidFill>
      <a:prstDash val="solid"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s-E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469" y="2800623"/>
            <a:ext cx="5830650" cy="193247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938" y="5108734"/>
            <a:ext cx="4801712" cy="230393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8664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6726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31093" y="398599"/>
            <a:ext cx="1157555" cy="8497861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235" y="398599"/>
            <a:ext cx="3359531" cy="8497861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2181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0307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860" y="5793238"/>
            <a:ext cx="5830650" cy="179056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860" y="3821118"/>
            <a:ext cx="5830650" cy="197212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9214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234" y="2322723"/>
            <a:ext cx="2257948" cy="65737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9510" y="2322723"/>
            <a:ext cx="2259139" cy="65737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8204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80" y="361034"/>
            <a:ext cx="6173629" cy="1502569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79" y="2018034"/>
            <a:ext cx="3030843" cy="84102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79" y="2859054"/>
            <a:ext cx="3030843" cy="519429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4577" y="2018034"/>
            <a:ext cx="3032033" cy="84102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4577" y="2859054"/>
            <a:ext cx="3032033" cy="519429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0799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805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6737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80" y="358947"/>
            <a:ext cx="2256757" cy="1527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908" y="358948"/>
            <a:ext cx="3834700" cy="76944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80" y="1886561"/>
            <a:ext cx="2256757" cy="616679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4358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528" y="6310789"/>
            <a:ext cx="4115753" cy="74502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528" y="805543"/>
            <a:ext cx="4115753" cy="540924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528" y="7055814"/>
            <a:ext cx="4115753" cy="10580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734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80" y="361034"/>
            <a:ext cx="6173629" cy="15025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80" y="2103598"/>
            <a:ext cx="6173629" cy="59497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80" y="8355953"/>
            <a:ext cx="1600571" cy="479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6FD52-C258-49F7-98A9-84C9273CD353}" type="datetimeFigureOut">
              <a:rPr lang="es-ES" smtClean="0"/>
              <a:t>07/08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694" y="8355953"/>
            <a:ext cx="2172203" cy="479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6039" y="8355953"/>
            <a:ext cx="1600571" cy="479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FA8C2-F7FF-4D7E-9D68-10862D67377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6513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3456825"/>
              </p:ext>
            </p:extLst>
          </p:nvPr>
        </p:nvGraphicFramePr>
        <p:xfrm>
          <a:off x="837506" y="691282"/>
          <a:ext cx="5228706" cy="3105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8581226"/>
              </p:ext>
            </p:extLst>
          </p:nvPr>
        </p:nvGraphicFramePr>
        <p:xfrm>
          <a:off x="1125538" y="4507706"/>
          <a:ext cx="4824536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545052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770978"/>
              </p:ext>
            </p:extLst>
          </p:nvPr>
        </p:nvGraphicFramePr>
        <p:xfrm>
          <a:off x="981522" y="403250"/>
          <a:ext cx="4790661" cy="3003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4583909"/>
              </p:ext>
            </p:extLst>
          </p:nvPr>
        </p:nvGraphicFramePr>
        <p:xfrm>
          <a:off x="765498" y="4363690"/>
          <a:ext cx="5328592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11887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6407522"/>
              </p:ext>
            </p:extLst>
          </p:nvPr>
        </p:nvGraphicFramePr>
        <p:xfrm>
          <a:off x="1053530" y="547266"/>
          <a:ext cx="4790661" cy="3003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9244265"/>
              </p:ext>
            </p:extLst>
          </p:nvPr>
        </p:nvGraphicFramePr>
        <p:xfrm>
          <a:off x="909514" y="4291682"/>
          <a:ext cx="5400600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594918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3327795"/>
              </p:ext>
            </p:extLst>
          </p:nvPr>
        </p:nvGraphicFramePr>
        <p:xfrm>
          <a:off x="1269554" y="475258"/>
          <a:ext cx="4790661" cy="3003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8835409"/>
              </p:ext>
            </p:extLst>
          </p:nvPr>
        </p:nvGraphicFramePr>
        <p:xfrm>
          <a:off x="693490" y="4147666"/>
          <a:ext cx="5616624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801104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5097206"/>
              </p:ext>
            </p:extLst>
          </p:nvPr>
        </p:nvGraphicFramePr>
        <p:xfrm>
          <a:off x="1053530" y="547266"/>
          <a:ext cx="4790661" cy="3003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4479654"/>
              </p:ext>
            </p:extLst>
          </p:nvPr>
        </p:nvGraphicFramePr>
        <p:xfrm>
          <a:off x="693490" y="4795738"/>
          <a:ext cx="5616624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371791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</Words>
  <Application>Microsoft Office PowerPoint</Application>
  <PresentationFormat>Personalizado</PresentationFormat>
  <Paragraphs>5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LATZ VILLATE BEJARANO</dc:creator>
  <cp:lastModifiedBy>OLATZ VILLATE BEJARANO</cp:lastModifiedBy>
  <cp:revision>6</cp:revision>
  <dcterms:created xsi:type="dcterms:W3CDTF">2019-08-07T10:38:38Z</dcterms:created>
  <dcterms:modified xsi:type="dcterms:W3CDTF">2019-08-07T11:25:56Z</dcterms:modified>
</cp:coreProperties>
</file>